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3" r:id="rId2"/>
  </p:sldIdLst>
  <p:sldSz cx="43200638" cy="32399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25" d="100"/>
          <a:sy n="25" d="100"/>
        </p:scale>
        <p:origin x="198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05902-9533-4F90-8B91-906D187C379C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43FEFD-333A-4C46-9EE1-A0705BF72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64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40048" y="5302386"/>
            <a:ext cx="36720542" cy="11279752"/>
          </a:xfrm>
        </p:spPr>
        <p:txBody>
          <a:bodyPr anchor="b"/>
          <a:lstStyle>
            <a:lvl1pPr algn="ctr"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00080" y="17017128"/>
            <a:ext cx="32400479" cy="7822326"/>
          </a:xfrm>
        </p:spPr>
        <p:txBody>
          <a:bodyPr/>
          <a:lstStyle>
            <a:lvl1pPr marL="0" indent="0" algn="ctr">
              <a:buNone/>
              <a:defRPr sz="11338"/>
            </a:lvl1pPr>
            <a:lvl2pPr marL="2159950" indent="0" algn="ctr">
              <a:buNone/>
              <a:defRPr sz="9449"/>
            </a:lvl2pPr>
            <a:lvl3pPr marL="4319900" indent="0" algn="ctr">
              <a:buNone/>
              <a:defRPr sz="8504"/>
            </a:lvl3pPr>
            <a:lvl4pPr marL="6479850" indent="0" algn="ctr">
              <a:buNone/>
              <a:defRPr sz="7559"/>
            </a:lvl4pPr>
            <a:lvl5pPr marL="8639800" indent="0" algn="ctr">
              <a:buNone/>
              <a:defRPr sz="7559"/>
            </a:lvl5pPr>
            <a:lvl6pPr marL="10799750" indent="0" algn="ctr">
              <a:buNone/>
              <a:defRPr sz="7559"/>
            </a:lvl6pPr>
            <a:lvl7pPr marL="12959700" indent="0" algn="ctr">
              <a:buNone/>
              <a:defRPr sz="7559"/>
            </a:lvl7pPr>
            <a:lvl8pPr marL="15119650" indent="0" algn="ctr">
              <a:buNone/>
              <a:defRPr sz="7559"/>
            </a:lvl8pPr>
            <a:lvl9pPr marL="17279600" indent="0" algn="ctr">
              <a:buNone/>
              <a:defRPr sz="7559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314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137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15459" y="1724962"/>
            <a:ext cx="9315138" cy="27456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70046" y="1724962"/>
            <a:ext cx="27405405" cy="2745689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70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733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7546" y="8077332"/>
            <a:ext cx="37260550" cy="13477201"/>
          </a:xfrm>
        </p:spPr>
        <p:txBody>
          <a:bodyPr anchor="b"/>
          <a:lstStyle>
            <a:lvl1pPr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7546" y="21682033"/>
            <a:ext cx="37260550" cy="7087342"/>
          </a:xfrm>
        </p:spPr>
        <p:txBody>
          <a:bodyPr/>
          <a:lstStyle>
            <a:lvl1pPr marL="0" indent="0">
              <a:buNone/>
              <a:defRPr sz="11338">
                <a:solidFill>
                  <a:schemeClr val="tx1"/>
                </a:solidFill>
              </a:defRPr>
            </a:lvl1pPr>
            <a:lvl2pPr marL="2159950" indent="0">
              <a:buNone/>
              <a:defRPr sz="9449">
                <a:solidFill>
                  <a:schemeClr val="tx1">
                    <a:tint val="75000"/>
                  </a:schemeClr>
                </a:solidFill>
              </a:defRPr>
            </a:lvl2pPr>
            <a:lvl3pPr marL="4319900" indent="0">
              <a:buNone/>
              <a:defRPr sz="8504">
                <a:solidFill>
                  <a:schemeClr val="tx1">
                    <a:tint val="75000"/>
                  </a:schemeClr>
                </a:solidFill>
              </a:defRPr>
            </a:lvl3pPr>
            <a:lvl4pPr marL="64798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4pPr>
            <a:lvl5pPr marL="86398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5pPr>
            <a:lvl6pPr marL="107997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6pPr>
            <a:lvl7pPr marL="129597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7pPr>
            <a:lvl8pPr marL="151196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8pPr>
            <a:lvl9pPr marL="172796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608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70044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70323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621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1724969"/>
            <a:ext cx="37260550" cy="626236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5675" y="7942328"/>
            <a:ext cx="18275892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5675" y="11834740"/>
            <a:ext cx="18275892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870325" y="7942328"/>
            <a:ext cx="18365898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870325" y="11834740"/>
            <a:ext cx="18365898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881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971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928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365898" y="4664905"/>
            <a:ext cx="21870323" cy="23024494"/>
          </a:xfrm>
        </p:spPr>
        <p:txBody>
          <a:bodyPr/>
          <a:lstStyle>
            <a:lvl1pPr>
              <a:defRPr sz="15118"/>
            </a:lvl1pPr>
            <a:lvl2pPr>
              <a:defRPr sz="13228"/>
            </a:lvl2pPr>
            <a:lvl3pPr>
              <a:defRPr sz="11338"/>
            </a:lvl3pPr>
            <a:lvl4pPr>
              <a:defRPr sz="9449"/>
            </a:lvl4pPr>
            <a:lvl5pPr>
              <a:defRPr sz="9449"/>
            </a:lvl5pPr>
            <a:lvl6pPr>
              <a:defRPr sz="9449"/>
            </a:lvl6pPr>
            <a:lvl7pPr>
              <a:defRPr sz="9449"/>
            </a:lvl7pPr>
            <a:lvl8pPr>
              <a:defRPr sz="9449"/>
            </a:lvl8pPr>
            <a:lvl9pPr>
              <a:defRPr sz="944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8997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365898" y="4664905"/>
            <a:ext cx="21870323" cy="23024494"/>
          </a:xfrm>
        </p:spPr>
        <p:txBody>
          <a:bodyPr anchor="t"/>
          <a:lstStyle>
            <a:lvl1pPr marL="0" indent="0">
              <a:buNone/>
              <a:defRPr sz="15118"/>
            </a:lvl1pPr>
            <a:lvl2pPr marL="2159950" indent="0">
              <a:buNone/>
              <a:defRPr sz="13228"/>
            </a:lvl2pPr>
            <a:lvl3pPr marL="4319900" indent="0">
              <a:buNone/>
              <a:defRPr sz="11338"/>
            </a:lvl3pPr>
            <a:lvl4pPr marL="6479850" indent="0">
              <a:buNone/>
              <a:defRPr sz="9449"/>
            </a:lvl4pPr>
            <a:lvl5pPr marL="8639800" indent="0">
              <a:buNone/>
              <a:defRPr sz="9449"/>
            </a:lvl5pPr>
            <a:lvl6pPr marL="10799750" indent="0">
              <a:buNone/>
              <a:defRPr sz="9449"/>
            </a:lvl6pPr>
            <a:lvl7pPr marL="12959700" indent="0">
              <a:buNone/>
              <a:defRPr sz="9449"/>
            </a:lvl7pPr>
            <a:lvl8pPr marL="15119650" indent="0">
              <a:buNone/>
              <a:defRPr sz="9449"/>
            </a:lvl8pPr>
            <a:lvl9pPr marL="17279600" indent="0">
              <a:buNone/>
              <a:defRPr sz="944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56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0044" y="1724969"/>
            <a:ext cx="37260550" cy="626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0044" y="8624810"/>
            <a:ext cx="37260550" cy="205570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0044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310212" y="30029347"/>
            <a:ext cx="14580215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510450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28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319900" rtl="0" eaLnBrk="1" latinLnBrk="0" hangingPunct="1">
        <a:lnSpc>
          <a:spcPct val="90000"/>
        </a:lnSpc>
        <a:spcBef>
          <a:spcPct val="0"/>
        </a:spcBef>
        <a:buNone/>
        <a:defRPr sz="207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75" indent="-1079975" algn="l" defTabSz="4319900" rtl="0" eaLnBrk="1" latinLnBrk="0" hangingPunct="1">
        <a:lnSpc>
          <a:spcPct val="90000"/>
        </a:lnSpc>
        <a:spcBef>
          <a:spcPts val="4724"/>
        </a:spcBef>
        <a:buFont typeface="Arial" panose="020B0604020202020204" pitchFamily="34" charset="0"/>
        <a:buChar char="•"/>
        <a:defRPr sz="13228" kern="1200">
          <a:solidFill>
            <a:schemeClr val="tx1"/>
          </a:solidFill>
          <a:latin typeface="+mn-lt"/>
          <a:ea typeface="+mn-ea"/>
          <a:cs typeface="+mn-cs"/>
        </a:defRPr>
      </a:lvl1pPr>
      <a:lvl2pPr marL="32399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11338" kern="1200">
          <a:solidFill>
            <a:schemeClr val="tx1"/>
          </a:solidFill>
          <a:latin typeface="+mn-lt"/>
          <a:ea typeface="+mn-ea"/>
          <a:cs typeface="+mn-cs"/>
        </a:defRPr>
      </a:lvl2pPr>
      <a:lvl3pPr marL="53998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3pPr>
      <a:lvl4pPr marL="75598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97197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18797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40396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61996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83595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1pPr>
      <a:lvl2pPr marL="21599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2pPr>
      <a:lvl3pPr marL="43199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3pPr>
      <a:lvl4pPr marL="64798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86398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07997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29597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51196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72796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798763" y="19484528"/>
            <a:ext cx="38806437" cy="82176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IGURE S7 Examination of the transcript level of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nd its derivatives in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strains using reverse transcription quantitative real-time PCR (RT-qPCR) assay.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strain wild-type strain GX01 and point-mutated strains </a:t>
            </a:r>
            <a:r>
              <a:rPr lang="en-US" altLang="zh-CN" sz="6600" dirty="0">
                <a:latin typeface="Arial Narrow" panose="020B0606020202030204" pitchFamily="34" charset="0"/>
              </a:rPr>
              <a:t>Δ</a:t>
            </a:r>
            <a:r>
              <a:rPr lang="en-US" altLang="zh-CN" sz="6600" i="1" dirty="0">
                <a:latin typeface="Arial Narrow" panose="020B0606020202030204" pitchFamily="34" charset="0"/>
              </a:rPr>
              <a:t>emvR</a:t>
            </a:r>
            <a:r>
              <a:rPr lang="en-US" altLang="zh-CN" sz="6600" i="1" baseline="-25000" dirty="0">
                <a:latin typeface="Arial Narrow" panose="020B0606020202030204" pitchFamily="34" charset="0"/>
              </a:rPr>
              <a:t>D15A</a:t>
            </a:r>
            <a:r>
              <a:rPr lang="en-US" altLang="zh-CN" sz="6600" dirty="0">
                <a:latin typeface="Arial Narrow" panose="020B0606020202030204" pitchFamily="34" charset="0"/>
              </a:rPr>
              <a:t>, Δ</a:t>
            </a:r>
            <a:r>
              <a:rPr lang="en-US" altLang="zh-CN" sz="6600" i="1" dirty="0">
                <a:latin typeface="Arial Narrow" panose="020B0606020202030204" pitchFamily="34" charset="0"/>
              </a:rPr>
              <a:t>emvR</a:t>
            </a:r>
            <a:r>
              <a:rPr lang="en-US" altLang="zh-CN" sz="6600" i="1" baseline="-25000" dirty="0">
                <a:latin typeface="Arial Narrow" panose="020B0606020202030204" pitchFamily="34" charset="0"/>
              </a:rPr>
              <a:t>D59A </a:t>
            </a:r>
            <a:r>
              <a:rPr lang="en-US" altLang="zh-CN" sz="6600" dirty="0">
                <a:latin typeface="Arial Narrow" panose="020B0606020202030204" pitchFamily="34" charset="0"/>
              </a:rPr>
              <a:t>and Δ</a:t>
            </a:r>
            <a:r>
              <a:rPr lang="en-US" altLang="zh-CN" sz="6600" i="1" dirty="0">
                <a:latin typeface="Arial Narrow" panose="020B0606020202030204" pitchFamily="34" charset="0"/>
              </a:rPr>
              <a:t>emvR</a:t>
            </a:r>
            <a:r>
              <a:rPr lang="en-US" altLang="zh-CN" sz="6600" i="1" baseline="-25000" dirty="0">
                <a:latin typeface="Arial Narrow" panose="020B0606020202030204" pitchFamily="34" charset="0"/>
              </a:rPr>
              <a:t>T87A</a:t>
            </a:r>
            <a:r>
              <a:rPr lang="en-US" altLang="zh-CN" sz="6600" dirty="0">
                <a:latin typeface="Arial Narrow" panose="020B0606020202030204" pitchFamily="34" charset="0"/>
              </a:rPr>
              <a:t> were 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ultured in NB medium, and RNAs were extracted. The RT-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qPC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tests were performed in triplicate. Values given are the mean ± 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D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 from triplicate measurements in a representative experiment. </a:t>
            </a:r>
            <a:endParaRPr lang="zh-CN" altLang="en-US" sz="6600" dirty="0">
              <a:latin typeface="Arial Narrow" panose="020B060602020203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10058401" y="457200"/>
            <a:ext cx="22494240" cy="16820125"/>
            <a:chOff x="10058401" y="457200"/>
            <a:chExt cx="22494240" cy="16820125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68" t="5065" r="3417" b="7589"/>
            <a:stretch/>
          </p:blipFill>
          <p:spPr bwMode="auto">
            <a:xfrm>
              <a:off x="10058401" y="457200"/>
              <a:ext cx="22494240" cy="15544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" name="组合 4"/>
            <p:cNvGrpSpPr/>
            <p:nvPr/>
          </p:nvGrpSpPr>
          <p:grpSpPr>
            <a:xfrm>
              <a:off x="11400561" y="15953886"/>
              <a:ext cx="17989580" cy="1323439"/>
              <a:chOff x="11400561" y="15953886"/>
              <a:chExt cx="17989580" cy="1323439"/>
            </a:xfrm>
          </p:grpSpPr>
          <p:sp>
            <p:nvSpPr>
              <p:cNvPr id="8" name="矩形 7"/>
              <p:cNvSpPr/>
              <p:nvPr/>
            </p:nvSpPr>
            <p:spPr>
              <a:xfrm rot="18900000">
                <a:off x="15288462" y="15986215"/>
                <a:ext cx="2122697" cy="120032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ctr" defTabSz="4319991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7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Narrow" panose="020B0606020202030204" pitchFamily="34" charset="0"/>
                    <a:ea typeface="宋体" panose="02010600030101010101" pitchFamily="2" charset="-122"/>
                  </a:rPr>
                  <a:t>GX01</a:t>
                </a:r>
                <a:endParaRPr kumimoji="0" lang="en-US" altLang="zh-CN" sz="7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Narrow" panose="020B060602020203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9" name="矩形 8"/>
              <p:cNvSpPr/>
              <p:nvPr/>
            </p:nvSpPr>
            <p:spPr>
              <a:xfrm rot="18900000">
                <a:off x="17342021" y="16015440"/>
                <a:ext cx="4289957" cy="120032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ctr" defTabSz="4319991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l-GR" altLang="zh-CN" sz="7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Narrow" panose="020B0606020202030204" pitchFamily="34" charset="0"/>
                    <a:ea typeface="宋体" panose="02010600030101010101" pitchFamily="2" charset="-122"/>
                  </a:rPr>
                  <a:t>Δ</a:t>
                </a:r>
                <a:r>
                  <a:rPr lang="en-US" altLang="zh-CN" sz="7200" b="1" i="1" kern="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宋体" panose="02010600030101010101" pitchFamily="2" charset="-122"/>
                  </a:rPr>
                  <a:t>emvR</a:t>
                </a:r>
                <a:r>
                  <a:rPr lang="en-US" altLang="zh-CN" sz="7200" b="1" i="1" kern="0" baseline="-2500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宋体" panose="02010600030101010101" pitchFamily="2" charset="-122"/>
                  </a:rPr>
                  <a:t>D15A</a:t>
                </a:r>
                <a:r>
                  <a:rPr kumimoji="0" lang="en-GB" altLang="zh-CN" sz="7200" b="1" i="1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Narrow" panose="020B0606020202030204" pitchFamily="34" charset="0"/>
                    <a:ea typeface="宋体" panose="02010600030101010101" pitchFamily="2" charset="-122"/>
                  </a:rPr>
                  <a:t> </a:t>
                </a:r>
              </a:p>
            </p:txBody>
          </p:sp>
          <p:sp>
            <p:nvSpPr>
              <p:cNvPr id="10" name="矩形 9"/>
              <p:cNvSpPr/>
              <p:nvPr/>
            </p:nvSpPr>
            <p:spPr>
              <a:xfrm rot="18900000">
                <a:off x="21303956" y="16015441"/>
                <a:ext cx="4289957" cy="120032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ctr" defTabSz="4319991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l-GR" altLang="zh-CN" sz="7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Narrow" panose="020B0606020202030204" pitchFamily="34" charset="0"/>
                    <a:ea typeface="宋体" panose="02010600030101010101" pitchFamily="2" charset="-122"/>
                  </a:rPr>
                  <a:t>Δ</a:t>
                </a:r>
                <a:r>
                  <a:rPr lang="en-GB" altLang="zh-CN" sz="7200" b="1" i="1" kern="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宋体" panose="02010600030101010101" pitchFamily="2" charset="-122"/>
                  </a:rPr>
                  <a:t>emvR</a:t>
                </a:r>
                <a:r>
                  <a:rPr lang="en-GB" altLang="zh-CN" sz="7200" b="1" i="1" kern="0" baseline="-2500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宋体" panose="02010600030101010101" pitchFamily="2" charset="-122"/>
                  </a:rPr>
                  <a:t>D59A</a:t>
                </a:r>
                <a:r>
                  <a:rPr kumimoji="0" lang="en-GB" altLang="zh-CN" sz="7200" b="1" i="1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Narrow" panose="020B0606020202030204" pitchFamily="34" charset="0"/>
                    <a:ea typeface="宋体" panose="02010600030101010101" pitchFamily="2" charset="-122"/>
                  </a:rPr>
                  <a:t> </a:t>
                </a: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11400561" y="15953886"/>
                <a:ext cx="2569934" cy="132343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0" b="1" dirty="0">
                    <a:latin typeface="Arial Narrow" panose="020B0606020202030204" pitchFamily="34" charset="0"/>
                    <a:ea typeface="宋体" panose="02010600030101010101" pitchFamily="2" charset="-122"/>
                  </a:rPr>
                  <a:t>Strain</a:t>
                </a:r>
                <a:endParaRPr lang="zh-CN" altLang="en-US" sz="80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12" name="矩形 11"/>
              <p:cNvSpPr/>
              <p:nvPr/>
            </p:nvSpPr>
            <p:spPr>
              <a:xfrm rot="18900000">
                <a:off x="25156290" y="16035278"/>
                <a:ext cx="4233851" cy="120032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ctr" defTabSz="4319991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l-GR" altLang="zh-CN" sz="7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Narrow" panose="020B0606020202030204" pitchFamily="34" charset="0"/>
                    <a:ea typeface="宋体" panose="02010600030101010101" pitchFamily="2" charset="-122"/>
                  </a:rPr>
                  <a:t>Δ</a:t>
                </a:r>
                <a:r>
                  <a:rPr lang="en-GB" altLang="zh-CN" sz="7200" b="1" i="1" kern="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宋体" panose="02010600030101010101" pitchFamily="2" charset="-122"/>
                  </a:rPr>
                  <a:t>emvR</a:t>
                </a:r>
                <a:r>
                  <a:rPr lang="en-GB" altLang="zh-CN" sz="7200" b="1" i="1" kern="0" baseline="-2500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宋体" panose="02010600030101010101" pitchFamily="2" charset="-122"/>
                  </a:rPr>
                  <a:t>T87A</a:t>
                </a:r>
                <a:r>
                  <a:rPr kumimoji="0" lang="en-GB" altLang="zh-CN" sz="7200" b="1" i="1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 Narrow" panose="020B0606020202030204" pitchFamily="34" charset="0"/>
                    <a:ea typeface="宋体" panose="02010600030101010101" pitchFamily="2" charset="-122"/>
                  </a:rPr>
                  <a:t>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78608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6</TotalTime>
  <Words>81</Words>
  <Application>Microsoft Macintosh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Arial Narrow</vt:lpstr>
      <vt:lpstr>Calibri</vt:lpstr>
      <vt:lpstr>Calibri Light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HAS</dc:creator>
  <cp:lastModifiedBy>Carol Jenner</cp:lastModifiedBy>
  <cp:revision>441</cp:revision>
  <dcterms:created xsi:type="dcterms:W3CDTF">2024-03-09T05:50:12Z</dcterms:created>
  <dcterms:modified xsi:type="dcterms:W3CDTF">2025-03-20T09:55:07Z</dcterms:modified>
</cp:coreProperties>
</file>